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61" r:id="rId2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316" autoAdjust="0"/>
  </p:normalViewPr>
  <p:slideViewPr>
    <p:cSldViewPr>
      <p:cViewPr varScale="1">
        <p:scale>
          <a:sx n="99" d="100"/>
          <a:sy n="99" d="100"/>
        </p:scale>
        <p:origin x="246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958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1098" y="0"/>
            <a:ext cx="2944958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FE1FA3-004D-4079-B795-F31FF1DB0FBA}" type="datetimeFigureOut">
              <a:rPr lang="en-GB" smtClean="0"/>
              <a:pPr/>
              <a:t>27/03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4958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1098" y="9429750"/>
            <a:ext cx="2944958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E3B4BF-DF9C-4056-AEEE-5C559605827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49160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22503-AE87-4197-8DC3-AF7D21EAE944}" type="datetimeFigureOut">
              <a:rPr lang="en-GB" smtClean="0"/>
              <a:pPr/>
              <a:t>27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7F49-22E8-415D-9E92-628F189C011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4939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22503-AE87-4197-8DC3-AF7D21EAE944}" type="datetimeFigureOut">
              <a:rPr lang="en-GB" smtClean="0"/>
              <a:pPr/>
              <a:t>27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7F49-22E8-415D-9E92-628F189C011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70384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22503-AE87-4197-8DC3-AF7D21EAE944}" type="datetimeFigureOut">
              <a:rPr lang="en-GB" smtClean="0"/>
              <a:pPr/>
              <a:t>27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7F49-22E8-415D-9E92-628F189C011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9727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22503-AE87-4197-8DC3-AF7D21EAE944}" type="datetimeFigureOut">
              <a:rPr lang="en-GB" smtClean="0"/>
              <a:pPr/>
              <a:t>27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7F49-22E8-415D-9E92-628F189C011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9294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22503-AE87-4197-8DC3-AF7D21EAE944}" type="datetimeFigureOut">
              <a:rPr lang="en-GB" smtClean="0"/>
              <a:pPr/>
              <a:t>27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7F49-22E8-415D-9E92-628F189C011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9453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22503-AE87-4197-8DC3-AF7D21EAE944}" type="datetimeFigureOut">
              <a:rPr lang="en-GB" smtClean="0"/>
              <a:pPr/>
              <a:t>27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7F49-22E8-415D-9E92-628F189C011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1583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22503-AE87-4197-8DC3-AF7D21EAE944}" type="datetimeFigureOut">
              <a:rPr lang="en-GB" smtClean="0"/>
              <a:pPr/>
              <a:t>27/03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7F49-22E8-415D-9E92-628F189C011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0745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22503-AE87-4197-8DC3-AF7D21EAE944}" type="datetimeFigureOut">
              <a:rPr lang="en-GB" smtClean="0"/>
              <a:pPr/>
              <a:t>27/03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7F49-22E8-415D-9E92-628F189C011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22186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22503-AE87-4197-8DC3-AF7D21EAE944}" type="datetimeFigureOut">
              <a:rPr lang="en-GB" smtClean="0"/>
              <a:pPr/>
              <a:t>27/03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7F49-22E8-415D-9E92-628F189C011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4132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22503-AE87-4197-8DC3-AF7D21EAE944}" type="datetimeFigureOut">
              <a:rPr lang="en-GB" smtClean="0"/>
              <a:pPr/>
              <a:t>27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7F49-22E8-415D-9E92-628F189C011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59765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622503-AE87-4197-8DC3-AF7D21EAE944}" type="datetimeFigureOut">
              <a:rPr lang="en-GB" smtClean="0"/>
              <a:pPr/>
              <a:t>27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7F49-22E8-415D-9E92-628F189C011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9005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622503-AE87-4197-8DC3-AF7D21EAE944}" type="datetimeFigureOut">
              <a:rPr lang="en-GB" smtClean="0"/>
              <a:pPr/>
              <a:t>27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E27F49-22E8-415D-9E92-628F189C011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61868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5576" y="1196752"/>
            <a:ext cx="3312368" cy="348181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95536" y="4869160"/>
            <a:ext cx="820312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. Transmission electron microscopy (TEM) of 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uninfected haemocytes compared to B) </a:t>
            </a:r>
            <a:r>
              <a:rPr lang="en-GB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GB" sz="11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vis</a:t>
            </a:r>
            <a:r>
              <a:rPr lang="en-GB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CG </a:t>
            </a:r>
            <a:r>
              <a:rPr lang="en-GB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lux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nfected haemocytes  (dose  1 x 10 7 CFU per larva) </a:t>
            </a:r>
            <a:r>
              <a:rPr lang="en-GB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in vivo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 96 h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from </a:t>
            </a:r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G. </a:t>
            </a:r>
            <a:r>
              <a:rPr lang="en-GB" sz="1100" b="1" i="1" smtClean="0">
                <a:latin typeface="Arial" panose="020B0604020202020204" pitchFamily="34" charset="0"/>
                <a:cs typeface="Arial" panose="020B0604020202020204" pitchFamily="34" charset="0"/>
              </a:rPr>
              <a:t>mellonella</a:t>
            </a:r>
            <a:r>
              <a:rPr lang="en-GB" sz="1100" b="1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emolymph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from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haemocoel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n=10) was extracted from uninfected and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vis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GG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lux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infected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llonella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uncturing the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arvae i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he last left pro-leg using a sterile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eedle.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emolymph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was pooled, processed and analysed using a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Tecnai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bioTWIN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transmission electron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icroscope. Scale bar represents 2 µM (A) and 500 nm (B). Figures A-B show the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emolymph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contains haemocytes (arrow) and B shows the ultrastructure of internalised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vis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CG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lux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in to cells (arrow head)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55576" y="119675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grpSp>
        <p:nvGrpSpPr>
          <p:cNvPr id="9" name="Group 8"/>
          <p:cNvGrpSpPr>
            <a:grpSpLocks noChangeAspect="1"/>
          </p:cNvGrpSpPr>
          <p:nvPr/>
        </p:nvGrpSpPr>
        <p:grpSpPr>
          <a:xfrm>
            <a:off x="4473514" y="1196752"/>
            <a:ext cx="4341192" cy="2592288"/>
            <a:chOff x="1000315" y="3461635"/>
            <a:chExt cx="2546890" cy="1520843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3"/>
            <a:srcRect b="2692"/>
            <a:stretch/>
          </p:blipFill>
          <p:spPr>
            <a:xfrm>
              <a:off x="1000315" y="3461635"/>
              <a:ext cx="2546890" cy="1520843"/>
            </a:xfrm>
            <a:prstGeom prst="rect">
              <a:avLst/>
            </a:prstGeom>
          </p:spPr>
        </p:pic>
        <p:cxnSp>
          <p:nvCxnSpPr>
            <p:cNvPr id="11" name="Straight Connector 10"/>
            <p:cNvCxnSpPr/>
            <p:nvPr/>
          </p:nvCxnSpPr>
          <p:spPr>
            <a:xfrm>
              <a:off x="3396853" y="4936707"/>
              <a:ext cx="11107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TextBox 11"/>
          <p:cNvSpPr txBox="1"/>
          <p:nvPr/>
        </p:nvSpPr>
        <p:spPr>
          <a:xfrm>
            <a:off x="4473514" y="119675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solidFill>
                  <a:schemeClr val="bg1"/>
                </a:solidFill>
              </a:rPr>
              <a:t>B</a:t>
            </a:r>
            <a:endParaRPr lang="en-GB" b="1" dirty="0">
              <a:solidFill>
                <a:schemeClr val="bg1"/>
              </a:solidFill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 flipV="1">
            <a:off x="5650046" y="2104797"/>
            <a:ext cx="2074" cy="28059"/>
          </a:xfrm>
          <a:prstGeom prst="straightConnector1">
            <a:avLst/>
          </a:prstGeom>
          <a:ln>
            <a:solidFill>
              <a:schemeClr val="bg1"/>
            </a:solidFill>
            <a:headEnd type="stealt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 flipV="1">
            <a:off x="6370126" y="1744757"/>
            <a:ext cx="2074" cy="28059"/>
          </a:xfrm>
          <a:prstGeom prst="straightConnector1">
            <a:avLst/>
          </a:prstGeom>
          <a:ln>
            <a:solidFill>
              <a:schemeClr val="bg1"/>
            </a:solidFill>
            <a:headEnd type="stealth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>
            <a:off x="4117979" y="1168802"/>
            <a:ext cx="222028" cy="64231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 flipH="1">
            <a:off x="3059832" y="1412776"/>
            <a:ext cx="288032" cy="20673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>
            <a:off x="5149351" y="1340768"/>
            <a:ext cx="367188" cy="206732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219495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63</TotalTime>
  <Words>141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Imperial Colleg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hara, Jasmeet</dc:creator>
  <cp:lastModifiedBy>Newton, Sandra M</cp:lastModifiedBy>
  <cp:revision>94</cp:revision>
  <cp:lastPrinted>2018-03-21T12:48:01Z</cp:lastPrinted>
  <dcterms:created xsi:type="dcterms:W3CDTF">2016-05-02T11:49:19Z</dcterms:created>
  <dcterms:modified xsi:type="dcterms:W3CDTF">2018-03-27T10:08:24Z</dcterms:modified>
</cp:coreProperties>
</file>